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2"/>
    <p:restoredTop sz="94647"/>
  </p:normalViewPr>
  <p:slideViewPr>
    <p:cSldViewPr snapToGrid="0" snapToObjects="1">
      <p:cViewPr varScale="1">
        <p:scale>
          <a:sx n="101" d="100"/>
          <a:sy n="101" d="100"/>
        </p:scale>
        <p:origin x="348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3023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8354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3838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576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4109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0789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3006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8253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1260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803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6239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CC1D8-3478-E74C-A4A2-507BFEA1B2F6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D8A5F8-374C-944E-B6DF-AB58CB7802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2947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.xls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008D8488-C4AD-7242-99D1-5829A786E93E}"/>
              </a:ext>
            </a:extLst>
          </p:cNvPr>
          <p:cNvSpPr txBox="1"/>
          <p:nvPr/>
        </p:nvSpPr>
        <p:spPr>
          <a:xfrm>
            <a:off x="106016" y="350690"/>
            <a:ext cx="3262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6. Seawater characteristics.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DDA3079-2551-6D45-927E-2D2444CDD477}"/>
              </a:ext>
            </a:extLst>
          </p:cNvPr>
          <p:cNvSpPr txBox="1"/>
          <p:nvPr/>
        </p:nvSpPr>
        <p:spPr>
          <a:xfrm>
            <a:off x="106016" y="2252089"/>
            <a:ext cx="6597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issox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dissolved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oxygen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concentration;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empmean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eawater temperature at mean depth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emprange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eawater temperature range at mean depth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lomean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chlorophyll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concentration at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depth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635E0143-9A9A-774B-89AC-B042F6DD3B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4311177"/>
              </p:ext>
            </p:extLst>
          </p:nvPr>
        </p:nvGraphicFramePr>
        <p:xfrm>
          <a:off x="114747" y="724900"/>
          <a:ext cx="6580188" cy="14299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Feuille de calcul" r:id="rId3" imgW="7950200" imgH="1727200" progId="Excel.Sheet.12">
                  <p:embed/>
                </p:oleObj>
              </mc:Choice>
              <mc:Fallback>
                <p:oleObj name="Feuille de calcul" r:id="rId3" imgW="7950200" imgH="17272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4747" y="724900"/>
                        <a:ext cx="6580188" cy="14299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151883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46</Words>
  <Application>Microsoft Macintosh PowerPoint</Application>
  <PresentationFormat>Format A4 (210 x 297 mm)</PresentationFormat>
  <Paragraphs>2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Feuille de calcul Microsoft Excel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Guillaume</cp:lastModifiedBy>
  <cp:revision>7</cp:revision>
  <dcterms:created xsi:type="dcterms:W3CDTF">2021-06-08T13:18:23Z</dcterms:created>
  <dcterms:modified xsi:type="dcterms:W3CDTF">2021-06-11T16:59:49Z</dcterms:modified>
</cp:coreProperties>
</file>